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2.wmf" ContentType="image/x-wmf"/>
  <Override PartName="/ppt/media/image3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86DF0-9D67-4B3F-8930-71B5747B9A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26565-713B-443B-B72E-06FCAE613E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E042D-677C-43A6-BEC2-331A2472DA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592BB-79CC-4B17-8D56-F4408CFDC1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24555-5F04-4759-9275-84960A74FB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DF342-4C6E-41C0-A350-FBFC8EBA54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0E9F3-D3FF-418A-A055-6339808745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9F144-8D05-4472-83A5-7D1942B87C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5E747-F40F-495C-816A-E6B5B73D9A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5179C-43F5-4CB9-AB66-1CBF593A05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2E640-AC96-4D81-A6AD-F4D031B4AB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B974F-1AF2-418B-AC2B-2F01974FA1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23C58E-4DDC-4BDA-864D-C51C1455BC5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99cc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404640"/>
            <a:ext cx="9144000" cy="233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0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000000"/>
                </a:solidFill>
                <a:latin typeface="Georgia"/>
                <a:ea typeface="Times New Roman"/>
              </a:rPr>
              <a:t>Illustration</a:t>
            </a:r>
            <a:endParaRPr b="0" lang="en-US" sz="8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27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6600cc"/>
                </a:solidFill>
                <a:latin typeface="Georgia"/>
                <a:ea typeface="Times New Roman"/>
              </a:rPr>
              <a:t>Based on data from 2007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763640" y="2924280"/>
            <a:ext cx="5585040" cy="3313080"/>
          </a:xfrm>
          <a:prstGeom prst="rect">
            <a:avLst/>
          </a:prstGeom>
          <a:ln w="76320">
            <a:solidFill>
              <a:srgbClr val="000000"/>
            </a:solidFill>
            <a:miter/>
          </a:ln>
        </p:spPr>
      </p:pic>
      <p:sp>
        <p:nvSpPr>
          <p:cNvPr id="43" name=""/>
          <p:cNvSpPr/>
          <p:nvPr/>
        </p:nvSpPr>
        <p:spPr>
          <a:xfrm>
            <a:off x="2830680" y="6308640"/>
            <a:ext cx="3457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Georgia"/>
              </a:rPr>
              <a:t>The studied sit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"/>
          <p:cNvSpPr/>
          <p:nvPr/>
        </p:nvSpPr>
        <p:spPr>
          <a:xfrm>
            <a:off x="283068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November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118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5940360" y="2182680"/>
            <a:ext cx="144360" cy="14472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943600" y="1785960"/>
            <a:ext cx="144360" cy="1443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5943600" y="96696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5945040" y="1352520"/>
            <a:ext cx="144720" cy="1443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229440" y="836640"/>
            <a:ext cx="2735280" cy="162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rviv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"/>
          <p:cNvSpPr/>
          <p:nvPr/>
        </p:nvSpPr>
        <p:spPr>
          <a:xfrm>
            <a:off x="280836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December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126" name=""/>
          <p:cNvSpPr/>
          <p:nvPr/>
        </p:nvSpPr>
        <p:spPr>
          <a:xfrm>
            <a:off x="7380360" y="765000"/>
            <a:ext cx="1366920" cy="1800360"/>
          </a:xfrm>
          <a:prstGeom prst="rect">
            <a:avLst/>
          </a:prstGeom>
          <a:solidFill>
            <a:srgbClr val="f8f8f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5940360" y="2182680"/>
            <a:ext cx="144360" cy="14472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5943600" y="1785960"/>
            <a:ext cx="144360" cy="1443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5943600" y="96696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5945040" y="1352520"/>
            <a:ext cx="144720" cy="1443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6229440" y="836640"/>
            <a:ext cx="2735280" cy="162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rviv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99cc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1209600" y="765000"/>
            <a:ext cx="6696000" cy="54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141560" y="765000"/>
            <a:ext cx="6840360" cy="261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The following 9 slides illustrate the dynamics of BBD over the studied site (10×10 m), during the disease season of 2007.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076400" y="3203640"/>
            <a:ext cx="6951600" cy="294912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 u="sng">
                <a:solidFill>
                  <a:srgbClr val="000000"/>
                </a:solidFill>
                <a:uFillTx/>
                <a:latin typeface="Arial"/>
              </a:rPr>
              <a:t>Terms and symbol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Susceptible - 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a coral that has the potential to be infected by BBD.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Re-infected - 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an infected coral that survived BBD infection (i.e., visible signs of BBD disappeared) in the previous season.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106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55640" y="5851440"/>
            <a:ext cx="144360" cy="14472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58880" y="5230800"/>
            <a:ext cx="144360" cy="1443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58880" y="460548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60320" y="4183200"/>
            <a:ext cx="144720" cy="1443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63560" y="3784680"/>
            <a:ext cx="144360" cy="14436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5834160" y="1916280"/>
            <a:ext cx="32036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Georgia"/>
              </a:rPr>
              <a:t>The studied area </a:t>
            </a:r>
            <a:r>
              <a:rPr b="1" lang="en-US" sz="1600" spc="-1" strike="noStrike">
                <a:solidFill>
                  <a:srgbClr val="000000"/>
                </a:solidFill>
                <a:latin typeface="Georgia"/>
              </a:rPr>
              <a:t>(3151 susceptible coral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"/>
          <p:cNvGrpSpPr/>
          <p:nvPr/>
        </p:nvGrpSpPr>
        <p:grpSpPr>
          <a:xfrm>
            <a:off x="6372360" y="1125360"/>
            <a:ext cx="2302920" cy="368280"/>
            <a:chOff x="6372360" y="1125360"/>
            <a:chExt cx="2302920" cy="368280"/>
          </a:xfrm>
        </p:grpSpPr>
        <p:sp>
          <p:nvSpPr>
            <p:cNvPr id="55" name=""/>
            <p:cNvSpPr/>
            <p:nvPr/>
          </p:nvSpPr>
          <p:spPr>
            <a:xfrm>
              <a:off x="6588000" y="1125360"/>
              <a:ext cx="208728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Susceptible cora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372360" y="1262160"/>
              <a:ext cx="71280" cy="72720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040" bIns="5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p:transition>
    <p:fade/>
  </p:transition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/>
          <p:nvPr/>
        </p:nvSpPr>
        <p:spPr>
          <a:xfrm>
            <a:off x="280836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May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1922400" y="4267080"/>
            <a:ext cx="141480" cy="14472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276720" y="2492280"/>
            <a:ext cx="141120" cy="14472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261040" y="4292640"/>
            <a:ext cx="14112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059280" y="5157720"/>
            <a:ext cx="649080" cy="433440"/>
          </a:xfrm>
          <a:prstGeom prst="rect">
            <a:avLst/>
          </a:prstGeom>
          <a:solidFill>
            <a:srgbClr val="f8f8f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402160" y="4149720"/>
            <a:ext cx="216000" cy="433440"/>
          </a:xfrm>
          <a:prstGeom prst="rect">
            <a:avLst/>
          </a:prstGeom>
          <a:solidFill>
            <a:srgbClr val="f8f8f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943600" y="111132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945040" y="1496880"/>
            <a:ext cx="144720" cy="1447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229440" y="981000"/>
            <a:ext cx="2735280" cy="785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"/>
          <p:cNvSpPr/>
          <p:nvPr/>
        </p:nvSpPr>
        <p:spPr>
          <a:xfrm>
            <a:off x="280836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June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3276720" y="2508120"/>
            <a:ext cx="142920" cy="14472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924200" y="4270320"/>
            <a:ext cx="142560" cy="14436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213000" y="5302080"/>
            <a:ext cx="142920" cy="14472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261040" y="4278240"/>
            <a:ext cx="142920" cy="14436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403960" y="4238640"/>
            <a:ext cx="142920" cy="14436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943600" y="111132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945040" y="1496880"/>
            <a:ext cx="144720" cy="1447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229440" y="981000"/>
            <a:ext cx="2735280" cy="785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"/>
          <p:cNvSpPr/>
          <p:nvPr/>
        </p:nvSpPr>
        <p:spPr>
          <a:xfrm>
            <a:off x="280836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July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81" name=""/>
          <p:cNvSpPr/>
          <p:nvPr/>
        </p:nvSpPr>
        <p:spPr>
          <a:xfrm>
            <a:off x="3276720" y="2508120"/>
            <a:ext cx="142920" cy="14472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213000" y="5302080"/>
            <a:ext cx="142920" cy="14472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261040" y="4278240"/>
            <a:ext cx="142920" cy="14436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403960" y="4238640"/>
            <a:ext cx="142920" cy="14436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5943600" y="1930320"/>
            <a:ext cx="144360" cy="1447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5943600" y="111132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945040" y="1496880"/>
            <a:ext cx="144720" cy="1447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229440" y="981000"/>
            <a:ext cx="2735280" cy="1202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"/>
          <p:cNvSpPr/>
          <p:nvPr/>
        </p:nvSpPr>
        <p:spPr>
          <a:xfrm>
            <a:off x="280836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August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92" name=""/>
          <p:cNvSpPr/>
          <p:nvPr/>
        </p:nvSpPr>
        <p:spPr>
          <a:xfrm>
            <a:off x="3213000" y="5302080"/>
            <a:ext cx="142920" cy="14472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261040" y="4278240"/>
            <a:ext cx="142920" cy="144360"/>
          </a:xfrm>
          <a:prstGeom prst="ellips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940360" y="2182680"/>
            <a:ext cx="144360" cy="14472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943600" y="1785960"/>
            <a:ext cx="144360" cy="1443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943600" y="96696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945040" y="1352520"/>
            <a:ext cx="144720" cy="1443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6229440" y="836640"/>
            <a:ext cx="2735280" cy="162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rviv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"/>
          <p:cNvSpPr/>
          <p:nvPr/>
        </p:nvSpPr>
        <p:spPr>
          <a:xfrm>
            <a:off x="280836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September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940360" y="2182680"/>
            <a:ext cx="144360" cy="14472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943600" y="1785960"/>
            <a:ext cx="144360" cy="1443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943600" y="96696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945040" y="1352520"/>
            <a:ext cx="144720" cy="1443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229440" y="836640"/>
            <a:ext cx="2735280" cy="162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rviv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8f8f8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"/>
          <p:cNvSpPr/>
          <p:nvPr/>
        </p:nvSpPr>
        <p:spPr>
          <a:xfrm>
            <a:off x="2808360" y="0"/>
            <a:ext cx="3492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8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Georgia"/>
              </a:rPr>
              <a:t>October 2007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" descr=""/>
          <p:cNvPicPr/>
          <p:nvPr/>
        </p:nvPicPr>
        <p:blipFill>
          <a:blip r:embed="rId1"/>
          <a:stretch/>
        </p:blipFill>
        <p:spPr>
          <a:xfrm>
            <a:off x="-73080" y="579600"/>
            <a:ext cx="9290160" cy="5705280"/>
          </a:xfrm>
          <a:prstGeom prst="rect">
            <a:avLst/>
          </a:prstGeom>
          <a:ln w="0">
            <a:noFill/>
          </a:ln>
        </p:spPr>
      </p:pic>
      <p:sp>
        <p:nvSpPr>
          <p:cNvPr id="110" name=""/>
          <p:cNvSpPr/>
          <p:nvPr/>
        </p:nvSpPr>
        <p:spPr>
          <a:xfrm>
            <a:off x="5915160" y="2949480"/>
            <a:ext cx="3041640" cy="3842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000000"/>
                </a:solidFill>
                <a:uFillTx/>
                <a:latin typeface="Arial"/>
              </a:rPr>
              <a:t>Term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Infect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showing active symptoms of BBD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-infected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–  an infected coral that survived BBD infection (i.e., visible signs of BBD disappeared) in the previous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Di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died due to BBD during the present disease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Survived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- a coral that survived BBD infection in the present season.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940360" y="2182680"/>
            <a:ext cx="144360" cy="144720"/>
          </a:xfrm>
          <a:prstGeom prst="ellipse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5943600" y="1785960"/>
            <a:ext cx="144360" cy="1443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5943600" y="966960"/>
            <a:ext cx="144360" cy="144360"/>
          </a:xfrm>
          <a:prstGeom prst="ellipse">
            <a:avLst/>
          </a:prstGeom>
          <a:solidFill>
            <a:srgbClr val="ff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5945040" y="1352520"/>
            <a:ext cx="144720" cy="1443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229440" y="836640"/>
            <a:ext cx="2735280" cy="1620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-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rviv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7T07:58:42Z</dcterms:created>
  <dc:creator>Assaf Zvoloni</dc:creator>
  <dc:description/>
  <dc:language>en-US</dc:language>
  <cp:lastModifiedBy>Assaf Zvoloni</cp:lastModifiedBy>
  <dcterms:modified xsi:type="dcterms:W3CDTF">2008-06-22T18:54:05Z</dcterms:modified>
  <cp:revision>67</cp:revision>
  <dc:subject/>
  <dc:title>Spatio-temporal transmission patterns of black band disease (BBD) in a coral community</dc:title>
</cp:coreProperties>
</file>